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f\Desktop\Brain%20Science%20Subdomain%20Analysis%20Based%20on%20Explanable%20Terminology%20Clustering\brainRegionRefCount2020071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wer"/>
            <c:dispRSqr val="1"/>
            <c:dispEq val="1"/>
            <c:trendlineLbl>
              <c:layout>
                <c:manualLayout>
                  <c:x val="3.542541557305337E-2"/>
                  <c:y val="-0.4024489647127442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yVal>
            <c:numRef>
              <c:f>distribution!$A$45:$A$64</c:f>
              <c:numCache>
                <c:formatCode>General</c:formatCode>
                <c:ptCount val="20"/>
                <c:pt idx="0">
                  <c:v>28115.029339467201</c:v>
                </c:pt>
                <c:pt idx="1">
                  <c:v>20272.600324509</c:v>
                </c:pt>
                <c:pt idx="2">
                  <c:v>15303.3604051371</c:v>
                </c:pt>
                <c:pt idx="3">
                  <c:v>11672.136329735</c:v>
                </c:pt>
                <c:pt idx="4">
                  <c:v>9933.4205450831996</c:v>
                </c:pt>
                <c:pt idx="5">
                  <c:v>8029.7452572889997</c:v>
                </c:pt>
                <c:pt idx="6">
                  <c:v>7769.4912924575401</c:v>
                </c:pt>
                <c:pt idx="7">
                  <c:v>7252.7976435601404</c:v>
                </c:pt>
                <c:pt idx="8">
                  <c:v>7186.7156628026496</c:v>
                </c:pt>
                <c:pt idx="9">
                  <c:v>6572.7221809744697</c:v>
                </c:pt>
                <c:pt idx="10">
                  <c:v>6461.5077292127498</c:v>
                </c:pt>
                <c:pt idx="11">
                  <c:v>6172.1281549867199</c:v>
                </c:pt>
                <c:pt idx="12">
                  <c:v>5898.7431996376599</c:v>
                </c:pt>
                <c:pt idx="13">
                  <c:v>5792.7367331560599</c:v>
                </c:pt>
                <c:pt idx="14">
                  <c:v>5788.1439249141304</c:v>
                </c:pt>
                <c:pt idx="15">
                  <c:v>5770.7936475099004</c:v>
                </c:pt>
                <c:pt idx="16">
                  <c:v>5586.1883417392701</c:v>
                </c:pt>
                <c:pt idx="17">
                  <c:v>5563.0051774151698</c:v>
                </c:pt>
                <c:pt idx="18">
                  <c:v>5153.5856789489499</c:v>
                </c:pt>
                <c:pt idx="19">
                  <c:v>5080.84807017228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C2E-4A29-897A-19FC43DE49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8298128"/>
        <c:axId val="1508299760"/>
      </c:scatterChart>
      <c:valAx>
        <c:axId val="1508298128"/>
        <c:scaling>
          <c:orientation val="minMax"/>
          <c:max val="20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8299760"/>
        <c:crosses val="autoZero"/>
        <c:crossBetween val="midCat"/>
      </c:valAx>
      <c:valAx>
        <c:axId val="15082997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82981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wer"/>
            <c:dispRSqr val="1"/>
            <c:dispEq val="1"/>
            <c:trendlineLbl>
              <c:layout>
                <c:manualLayout>
                  <c:x val="7.3318022747156609E-3"/>
                  <c:y val="-0.4992209827938174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distribution!$A$2:$A$39</c:f>
              <c:numCache>
                <c:formatCode>General</c:formatCode>
                <c:ptCount val="38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  <c:pt idx="4">
                  <c:v>60</c:v>
                </c:pt>
                <c:pt idx="5">
                  <c:v>70</c:v>
                </c:pt>
                <c:pt idx="6">
                  <c:v>80</c:v>
                </c:pt>
                <c:pt idx="7">
                  <c:v>90</c:v>
                </c:pt>
                <c:pt idx="8">
                  <c:v>100</c:v>
                </c:pt>
                <c:pt idx="9">
                  <c:v>110</c:v>
                </c:pt>
                <c:pt idx="10">
                  <c:v>120</c:v>
                </c:pt>
                <c:pt idx="11">
                  <c:v>130</c:v>
                </c:pt>
                <c:pt idx="12">
                  <c:v>140</c:v>
                </c:pt>
                <c:pt idx="13">
                  <c:v>150</c:v>
                </c:pt>
                <c:pt idx="14">
                  <c:v>160</c:v>
                </c:pt>
                <c:pt idx="15">
                  <c:v>170</c:v>
                </c:pt>
                <c:pt idx="16">
                  <c:v>180</c:v>
                </c:pt>
                <c:pt idx="17">
                  <c:v>190</c:v>
                </c:pt>
                <c:pt idx="18">
                  <c:v>200</c:v>
                </c:pt>
                <c:pt idx="19">
                  <c:v>210</c:v>
                </c:pt>
                <c:pt idx="20">
                  <c:v>220</c:v>
                </c:pt>
                <c:pt idx="21">
                  <c:v>230</c:v>
                </c:pt>
                <c:pt idx="22">
                  <c:v>240</c:v>
                </c:pt>
                <c:pt idx="23">
                  <c:v>250</c:v>
                </c:pt>
                <c:pt idx="24">
                  <c:v>260</c:v>
                </c:pt>
                <c:pt idx="25">
                  <c:v>270</c:v>
                </c:pt>
                <c:pt idx="26">
                  <c:v>280</c:v>
                </c:pt>
                <c:pt idx="27">
                  <c:v>290</c:v>
                </c:pt>
                <c:pt idx="28">
                  <c:v>300</c:v>
                </c:pt>
                <c:pt idx="29">
                  <c:v>310</c:v>
                </c:pt>
                <c:pt idx="30">
                  <c:v>320</c:v>
                </c:pt>
                <c:pt idx="31">
                  <c:v>330</c:v>
                </c:pt>
                <c:pt idx="32">
                  <c:v>340</c:v>
                </c:pt>
                <c:pt idx="33">
                  <c:v>350</c:v>
                </c:pt>
                <c:pt idx="34">
                  <c:v>360</c:v>
                </c:pt>
                <c:pt idx="35">
                  <c:v>370</c:v>
                </c:pt>
                <c:pt idx="36">
                  <c:v>380</c:v>
                </c:pt>
                <c:pt idx="37">
                  <c:v>390</c:v>
                </c:pt>
              </c:numCache>
            </c:numRef>
          </c:xVal>
          <c:yVal>
            <c:numRef>
              <c:f>distribution!$B$2:$B$39</c:f>
              <c:numCache>
                <c:formatCode>General</c:formatCode>
                <c:ptCount val="38"/>
                <c:pt idx="0">
                  <c:v>5983</c:v>
                </c:pt>
                <c:pt idx="1">
                  <c:v>3319</c:v>
                </c:pt>
                <c:pt idx="2">
                  <c:v>2159</c:v>
                </c:pt>
                <c:pt idx="3">
                  <c:v>1523</c:v>
                </c:pt>
                <c:pt idx="4">
                  <c:v>1156</c:v>
                </c:pt>
                <c:pt idx="5">
                  <c:v>972</c:v>
                </c:pt>
                <c:pt idx="6">
                  <c:v>779</c:v>
                </c:pt>
                <c:pt idx="7">
                  <c:v>614</c:v>
                </c:pt>
                <c:pt idx="8">
                  <c:v>515</c:v>
                </c:pt>
                <c:pt idx="9">
                  <c:v>490</c:v>
                </c:pt>
                <c:pt idx="10">
                  <c:v>386</c:v>
                </c:pt>
                <c:pt idx="11">
                  <c:v>354</c:v>
                </c:pt>
                <c:pt idx="12">
                  <c:v>270</c:v>
                </c:pt>
                <c:pt idx="13">
                  <c:v>271</c:v>
                </c:pt>
                <c:pt idx="14">
                  <c:v>238</c:v>
                </c:pt>
                <c:pt idx="15">
                  <c:v>207</c:v>
                </c:pt>
                <c:pt idx="16">
                  <c:v>178</c:v>
                </c:pt>
                <c:pt idx="17">
                  <c:v>171</c:v>
                </c:pt>
                <c:pt idx="18">
                  <c:v>147</c:v>
                </c:pt>
                <c:pt idx="19">
                  <c:v>132</c:v>
                </c:pt>
                <c:pt idx="20">
                  <c:v>167</c:v>
                </c:pt>
                <c:pt idx="21">
                  <c:v>144</c:v>
                </c:pt>
                <c:pt idx="22">
                  <c:v>125</c:v>
                </c:pt>
                <c:pt idx="23">
                  <c:v>126</c:v>
                </c:pt>
                <c:pt idx="24">
                  <c:v>103</c:v>
                </c:pt>
                <c:pt idx="25">
                  <c:v>96</c:v>
                </c:pt>
                <c:pt idx="26">
                  <c:v>86</c:v>
                </c:pt>
                <c:pt idx="27">
                  <c:v>75</c:v>
                </c:pt>
                <c:pt idx="28">
                  <c:v>72</c:v>
                </c:pt>
                <c:pt idx="29">
                  <c:v>75</c:v>
                </c:pt>
                <c:pt idx="30">
                  <c:v>65</c:v>
                </c:pt>
                <c:pt idx="31">
                  <c:v>49</c:v>
                </c:pt>
                <c:pt idx="32">
                  <c:v>68</c:v>
                </c:pt>
                <c:pt idx="33">
                  <c:v>45</c:v>
                </c:pt>
                <c:pt idx="34">
                  <c:v>52</c:v>
                </c:pt>
                <c:pt idx="35">
                  <c:v>46</c:v>
                </c:pt>
                <c:pt idx="36">
                  <c:v>40</c:v>
                </c:pt>
                <c:pt idx="37">
                  <c:v>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149-4ADA-93D0-5026B00083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8292144"/>
        <c:axId val="1508300848"/>
      </c:scatterChart>
      <c:valAx>
        <c:axId val="1508292144"/>
        <c:scaling>
          <c:orientation val="minMax"/>
          <c:max val="4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8300848"/>
        <c:crosses val="autoZero"/>
        <c:crossBetween val="midCat"/>
      </c:valAx>
      <c:valAx>
        <c:axId val="15083008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082921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wer"/>
            <c:dispRSqr val="1"/>
            <c:dispEq val="1"/>
            <c:trendlineLbl>
              <c:layout>
                <c:manualLayout>
                  <c:x val="-1.719663962958206E-2"/>
                  <c:y val="-0.2729288781595710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baseline="0"/>
                      <a:t>y = </a:t>
                    </a:r>
                    <a:r>
                      <a:rPr lang="en-US" altLang="zh-CN" baseline="0" smtClean="0"/>
                      <a:t>2.12Ex</a:t>
                    </a:r>
                    <a:r>
                      <a:rPr lang="en-US" altLang="zh-CN" baseline="30000" smtClean="0"/>
                      <a:t>-0.751</a:t>
                    </a:r>
                    <a:r>
                      <a:rPr lang="en-US" altLang="zh-CN" baseline="0"/>
                      <a:t/>
                    </a:r>
                    <a:br>
                      <a:rPr lang="en-US" altLang="zh-CN" baseline="0"/>
                    </a:br>
                    <a:r>
                      <a:rPr lang="en-US" altLang="zh-CN" baseline="0"/>
                      <a:t>R² = </a:t>
                    </a:r>
                    <a:r>
                      <a:rPr lang="en-US" altLang="zh-CN" baseline="0" smtClean="0"/>
                      <a:t>0.93</a:t>
                    </a:r>
                    <a:endParaRPr lang="en-US" altLang="zh-CN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cat>
            <c:strRef>
              <c:f>brainRegionRefCount0!$B$1:$B$30</c:f>
              <c:strCache>
                <c:ptCount val="30"/>
                <c:pt idx="0">
                  <c:v>hippocampus</c:v>
                </c:pt>
                <c:pt idx="1">
                  <c:v>prefrontal cortex</c:v>
                </c:pt>
                <c:pt idx="2">
                  <c:v>hypothalamus</c:v>
                </c:pt>
                <c:pt idx="3">
                  <c:v>brain stem</c:v>
                </c:pt>
                <c:pt idx="4">
                  <c:v>basal ganglia</c:v>
                </c:pt>
                <c:pt idx="5">
                  <c:v>frontal cortex</c:v>
                </c:pt>
                <c:pt idx="6">
                  <c:v>cerebellum</c:v>
                </c:pt>
                <c:pt idx="7">
                  <c:v>anterior cingulate cortex</c:v>
                </c:pt>
                <c:pt idx="8">
                  <c:v>amygdala</c:v>
                </c:pt>
                <c:pt idx="9">
                  <c:v>visual cortex</c:v>
                </c:pt>
                <c:pt idx="10">
                  <c:v>corpus callosum</c:v>
                </c:pt>
                <c:pt idx="11">
                  <c:v>motor cortex</c:v>
                </c:pt>
                <c:pt idx="12">
                  <c:v>cerebellar</c:v>
                </c:pt>
                <c:pt idx="13">
                  <c:v>striatum</c:v>
                </c:pt>
                <c:pt idx="14">
                  <c:v>nucleus accumbens</c:v>
                </c:pt>
                <c:pt idx="15">
                  <c:v>thalamus</c:v>
                </c:pt>
                <c:pt idx="16">
                  <c:v>substantia nigra</c:v>
                </c:pt>
                <c:pt idx="17">
                  <c:v>temporal lobe</c:v>
                </c:pt>
                <c:pt idx="18">
                  <c:v>ventral tegmental area</c:v>
                </c:pt>
                <c:pt idx="19">
                  <c:v>medial prefrontal cortex</c:v>
                </c:pt>
                <c:pt idx="20">
                  <c:v>primary visual cortex</c:v>
                </c:pt>
                <c:pt idx="21">
                  <c:v>ca1</c:v>
                </c:pt>
                <c:pt idx="22">
                  <c:v>frontal lobe</c:v>
                </c:pt>
                <c:pt idx="23">
                  <c:v>medial temporal lobe</c:v>
                </c:pt>
                <c:pt idx="24">
                  <c:v>entorhinal cortex</c:v>
                </c:pt>
                <c:pt idx="25">
                  <c:v>parietal cortex</c:v>
                </c:pt>
                <c:pt idx="26">
                  <c:v>dorsolateral prefrontal cortex</c:v>
                </c:pt>
                <c:pt idx="27">
                  <c:v>orbitofrontal cortex</c:v>
                </c:pt>
                <c:pt idx="28">
                  <c:v>primary motor cortex</c:v>
                </c:pt>
                <c:pt idx="29">
                  <c:v>medial prefrontal cortex (mpfc)</c:v>
                </c:pt>
              </c:strCache>
            </c:strRef>
          </c:cat>
          <c:val>
            <c:numRef>
              <c:f>brainRegionRefCount0!$C$1:$C$30</c:f>
              <c:numCache>
                <c:formatCode>General</c:formatCode>
                <c:ptCount val="30"/>
                <c:pt idx="0">
                  <c:v>220503</c:v>
                </c:pt>
                <c:pt idx="1">
                  <c:v>102151</c:v>
                </c:pt>
                <c:pt idx="2">
                  <c:v>75833</c:v>
                </c:pt>
                <c:pt idx="3">
                  <c:v>56607</c:v>
                </c:pt>
                <c:pt idx="4">
                  <c:v>54403</c:v>
                </c:pt>
                <c:pt idx="5">
                  <c:v>54064</c:v>
                </c:pt>
                <c:pt idx="6">
                  <c:v>53849</c:v>
                </c:pt>
                <c:pt idx="7">
                  <c:v>52822</c:v>
                </c:pt>
                <c:pt idx="8">
                  <c:v>51210</c:v>
                </c:pt>
                <c:pt idx="9">
                  <c:v>50199</c:v>
                </c:pt>
                <c:pt idx="10">
                  <c:v>47333</c:v>
                </c:pt>
                <c:pt idx="11">
                  <c:v>38130</c:v>
                </c:pt>
                <c:pt idx="12">
                  <c:v>36285</c:v>
                </c:pt>
                <c:pt idx="13">
                  <c:v>32473</c:v>
                </c:pt>
                <c:pt idx="14">
                  <c:v>31484</c:v>
                </c:pt>
                <c:pt idx="15">
                  <c:v>28085</c:v>
                </c:pt>
                <c:pt idx="16">
                  <c:v>27028</c:v>
                </c:pt>
                <c:pt idx="17">
                  <c:v>26162</c:v>
                </c:pt>
                <c:pt idx="18">
                  <c:v>25630</c:v>
                </c:pt>
                <c:pt idx="19">
                  <c:v>24524</c:v>
                </c:pt>
                <c:pt idx="20">
                  <c:v>22008</c:v>
                </c:pt>
                <c:pt idx="21">
                  <c:v>21194</c:v>
                </c:pt>
                <c:pt idx="22">
                  <c:v>21184</c:v>
                </c:pt>
                <c:pt idx="23">
                  <c:v>18427</c:v>
                </c:pt>
                <c:pt idx="24">
                  <c:v>18087</c:v>
                </c:pt>
                <c:pt idx="25">
                  <c:v>17077</c:v>
                </c:pt>
                <c:pt idx="26">
                  <c:v>14521</c:v>
                </c:pt>
                <c:pt idx="27">
                  <c:v>13397</c:v>
                </c:pt>
                <c:pt idx="28">
                  <c:v>12870</c:v>
                </c:pt>
                <c:pt idx="29">
                  <c:v>12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C57-4BE6-8C20-C933728557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7484008"/>
        <c:axId val="757479088"/>
      </c:lineChart>
      <c:catAx>
        <c:axId val="757484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57479088"/>
        <c:crosses val="autoZero"/>
        <c:auto val="1"/>
        <c:lblAlgn val="ctr"/>
        <c:lblOffset val="100"/>
        <c:noMultiLvlLbl val="0"/>
      </c:catAx>
      <c:valAx>
        <c:axId val="757479088"/>
        <c:scaling>
          <c:orientation val="minMax"/>
        </c:scaling>
        <c:delete val="0"/>
        <c:axPos val="l"/>
        <c:numFmt formatCode="#,##0_);[Red]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57484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4997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615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593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5915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8046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28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9082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0531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4203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9841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1468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79F6C-AD71-42B5-9130-C1FCC06D6A85}" type="datetimeFigureOut">
              <a:rPr lang="zh-CN" altLang="en-US" smtClean="0"/>
              <a:t>2020/8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E26994-6F90-4AF6-B034-83441B32D6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2930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024312" y="1491659"/>
            <a:ext cx="2584336" cy="41471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Word Extraction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24312" y="3381411"/>
            <a:ext cx="2584336" cy="4082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Corpus Production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1024311" y="5264695"/>
            <a:ext cx="2584337" cy="66874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Word Representation Training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3966326" y="2523117"/>
            <a:ext cx="2584336" cy="41471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Manual Organization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3966326" y="3374943"/>
            <a:ext cx="2584336" cy="41471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Clustering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3" name="圆角矩形 22"/>
          <p:cNvSpPr/>
          <p:nvPr/>
        </p:nvSpPr>
        <p:spPr>
          <a:xfrm>
            <a:off x="1371600" y="329732"/>
            <a:ext cx="1889760" cy="78232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Corpus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4" name="圆角矩形 23"/>
          <p:cNvSpPr/>
          <p:nvPr/>
        </p:nvSpPr>
        <p:spPr>
          <a:xfrm>
            <a:off x="1371600" y="4116617"/>
            <a:ext cx="1889760" cy="78232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Term Replaced Corpus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5" name="圆角矩形 24"/>
          <p:cNvSpPr/>
          <p:nvPr/>
        </p:nvSpPr>
        <p:spPr>
          <a:xfrm>
            <a:off x="1371600" y="2243503"/>
            <a:ext cx="1889760" cy="78232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Methods and Keywords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6" name="圆角矩形 25"/>
          <p:cNvSpPr/>
          <p:nvPr/>
        </p:nvSpPr>
        <p:spPr>
          <a:xfrm>
            <a:off x="4324004" y="1249903"/>
            <a:ext cx="1889760" cy="78232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KOS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7" name="剪去对角的矩形 26"/>
          <p:cNvSpPr/>
          <p:nvPr/>
        </p:nvSpPr>
        <p:spPr>
          <a:xfrm>
            <a:off x="7683038" y="852501"/>
            <a:ext cx="2255520" cy="601283"/>
          </a:xfrm>
          <a:prstGeom prst="snip2DiagRect">
            <a:avLst>
              <a:gd name="adj1" fmla="val 50000"/>
              <a:gd name="adj2" fmla="val 0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Domain Topic Detection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8" name="剪去对角的矩形 27"/>
          <p:cNvSpPr/>
          <p:nvPr/>
        </p:nvSpPr>
        <p:spPr>
          <a:xfrm>
            <a:off x="7683038" y="2032223"/>
            <a:ext cx="2255520" cy="886917"/>
          </a:xfrm>
          <a:prstGeom prst="snip2DiagRect">
            <a:avLst>
              <a:gd name="adj1" fmla="val 50000"/>
              <a:gd name="adj2" fmla="val 0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Finding Subdomain Articles 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9" name="剪去对角的矩形 28"/>
          <p:cNvSpPr/>
          <p:nvPr/>
        </p:nvSpPr>
        <p:spPr>
          <a:xfrm>
            <a:off x="7683038" y="3476786"/>
            <a:ext cx="2255520" cy="601283"/>
          </a:xfrm>
          <a:prstGeom prst="snip2DiagRect">
            <a:avLst>
              <a:gd name="adj1" fmla="val 50000"/>
              <a:gd name="adj2" fmla="val 0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Clustering Articles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30" name="圆角矩形 29"/>
          <p:cNvSpPr/>
          <p:nvPr/>
        </p:nvSpPr>
        <p:spPr>
          <a:xfrm>
            <a:off x="4324004" y="4549877"/>
            <a:ext cx="1889760" cy="78232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Word Representation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31" name="圆角矩形 30"/>
          <p:cNvSpPr/>
          <p:nvPr/>
        </p:nvSpPr>
        <p:spPr>
          <a:xfrm>
            <a:off x="4324004" y="5600884"/>
            <a:ext cx="1889760" cy="78232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Article Representation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32" name="剪去对角的矩形 31"/>
          <p:cNvSpPr/>
          <p:nvPr/>
        </p:nvSpPr>
        <p:spPr>
          <a:xfrm>
            <a:off x="7683038" y="4563093"/>
            <a:ext cx="2255520" cy="967167"/>
          </a:xfrm>
          <a:prstGeom prst="snip2DiagRect">
            <a:avLst>
              <a:gd name="adj1" fmla="val 50000"/>
              <a:gd name="adj2" fmla="val 0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mtClean="0">
                <a:solidFill>
                  <a:schemeClr val="tx1"/>
                </a:solidFill>
              </a:rPr>
              <a:t>Characterizing Article Cluster Features</a:t>
            </a:r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34" name="直接箭头连接符 33"/>
          <p:cNvCxnSpPr>
            <a:stCxn id="23" idx="2"/>
            <a:endCxn id="4" idx="0"/>
          </p:cNvCxnSpPr>
          <p:nvPr/>
        </p:nvCxnSpPr>
        <p:spPr>
          <a:xfrm>
            <a:off x="2316480" y="1112052"/>
            <a:ext cx="0" cy="3796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/>
          <p:cNvCxnSpPr>
            <a:stCxn id="4" idx="2"/>
            <a:endCxn id="25" idx="0"/>
          </p:cNvCxnSpPr>
          <p:nvPr/>
        </p:nvCxnSpPr>
        <p:spPr>
          <a:xfrm>
            <a:off x="2316480" y="1906376"/>
            <a:ext cx="0" cy="3371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/>
          <p:cNvCxnSpPr>
            <a:stCxn id="25" idx="2"/>
            <a:endCxn id="17" idx="0"/>
          </p:cNvCxnSpPr>
          <p:nvPr/>
        </p:nvCxnSpPr>
        <p:spPr>
          <a:xfrm>
            <a:off x="2316480" y="3025823"/>
            <a:ext cx="0" cy="3555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>
            <a:stCxn id="17" idx="2"/>
            <a:endCxn id="24" idx="0"/>
          </p:cNvCxnSpPr>
          <p:nvPr/>
        </p:nvCxnSpPr>
        <p:spPr>
          <a:xfrm>
            <a:off x="2316480" y="3789660"/>
            <a:ext cx="0" cy="3269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>
            <a:stCxn id="24" idx="2"/>
            <a:endCxn id="18" idx="0"/>
          </p:cNvCxnSpPr>
          <p:nvPr/>
        </p:nvCxnSpPr>
        <p:spPr>
          <a:xfrm>
            <a:off x="2316480" y="4898937"/>
            <a:ext cx="0" cy="36575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/>
          <p:cNvCxnSpPr>
            <a:stCxn id="18" idx="3"/>
            <a:endCxn id="31" idx="1"/>
          </p:cNvCxnSpPr>
          <p:nvPr/>
        </p:nvCxnSpPr>
        <p:spPr>
          <a:xfrm>
            <a:off x="3608648" y="5599068"/>
            <a:ext cx="715356" cy="3929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/>
          <p:cNvCxnSpPr>
            <a:stCxn id="18" idx="3"/>
            <a:endCxn id="30" idx="1"/>
          </p:cNvCxnSpPr>
          <p:nvPr/>
        </p:nvCxnSpPr>
        <p:spPr>
          <a:xfrm flipV="1">
            <a:off x="3608648" y="4941037"/>
            <a:ext cx="715356" cy="6580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箭头连接符 48"/>
          <p:cNvCxnSpPr>
            <a:stCxn id="30" idx="0"/>
            <a:endCxn id="21" idx="2"/>
          </p:cNvCxnSpPr>
          <p:nvPr/>
        </p:nvCxnSpPr>
        <p:spPr>
          <a:xfrm flipH="1" flipV="1">
            <a:off x="5258494" y="3789660"/>
            <a:ext cx="10390" cy="7602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/>
          <p:cNvCxnSpPr>
            <a:stCxn id="21" idx="0"/>
            <a:endCxn id="20" idx="2"/>
          </p:cNvCxnSpPr>
          <p:nvPr/>
        </p:nvCxnSpPr>
        <p:spPr>
          <a:xfrm flipV="1">
            <a:off x="5258494" y="2937834"/>
            <a:ext cx="0" cy="4371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53"/>
          <p:cNvCxnSpPr>
            <a:stCxn id="20" idx="0"/>
            <a:endCxn id="26" idx="2"/>
          </p:cNvCxnSpPr>
          <p:nvPr/>
        </p:nvCxnSpPr>
        <p:spPr>
          <a:xfrm flipV="1">
            <a:off x="5258494" y="2032223"/>
            <a:ext cx="10390" cy="4908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连接符 57"/>
          <p:cNvCxnSpPr>
            <a:stCxn id="23" idx="1"/>
          </p:cNvCxnSpPr>
          <p:nvPr/>
        </p:nvCxnSpPr>
        <p:spPr>
          <a:xfrm flipH="1">
            <a:off x="533400" y="720892"/>
            <a:ext cx="8382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/>
        </p:nvCxnSpPr>
        <p:spPr>
          <a:xfrm>
            <a:off x="508000" y="720892"/>
            <a:ext cx="0" cy="286140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箭头连接符 61"/>
          <p:cNvCxnSpPr>
            <a:endCxn id="17" idx="1"/>
          </p:cNvCxnSpPr>
          <p:nvPr/>
        </p:nvCxnSpPr>
        <p:spPr>
          <a:xfrm>
            <a:off x="533400" y="3582301"/>
            <a:ext cx="490912" cy="32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箭头连接符 63"/>
          <p:cNvCxnSpPr>
            <a:stCxn id="26" idx="3"/>
          </p:cNvCxnSpPr>
          <p:nvPr/>
        </p:nvCxnSpPr>
        <p:spPr>
          <a:xfrm flipV="1">
            <a:off x="6213764" y="1249903"/>
            <a:ext cx="1330036" cy="3911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>
            <a:stCxn id="24" idx="3"/>
          </p:cNvCxnSpPr>
          <p:nvPr/>
        </p:nvCxnSpPr>
        <p:spPr>
          <a:xfrm flipV="1">
            <a:off x="3261360" y="4169768"/>
            <a:ext cx="347288" cy="33800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3608648" y="4169768"/>
            <a:ext cx="345062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箭头连接符 71"/>
          <p:cNvCxnSpPr/>
          <p:nvPr/>
        </p:nvCxnSpPr>
        <p:spPr>
          <a:xfrm flipV="1">
            <a:off x="7059277" y="2692400"/>
            <a:ext cx="552256" cy="14773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箭头连接符 76"/>
          <p:cNvCxnSpPr/>
          <p:nvPr/>
        </p:nvCxnSpPr>
        <p:spPr>
          <a:xfrm>
            <a:off x="7059277" y="4169768"/>
            <a:ext cx="484523" cy="10949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箭头连接符 78"/>
          <p:cNvCxnSpPr>
            <a:stCxn id="26" idx="3"/>
          </p:cNvCxnSpPr>
          <p:nvPr/>
        </p:nvCxnSpPr>
        <p:spPr>
          <a:xfrm>
            <a:off x="6213764" y="1641063"/>
            <a:ext cx="1330036" cy="10513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箭头连接符 80"/>
          <p:cNvCxnSpPr>
            <a:stCxn id="31" idx="3"/>
          </p:cNvCxnSpPr>
          <p:nvPr/>
        </p:nvCxnSpPr>
        <p:spPr>
          <a:xfrm flipV="1">
            <a:off x="6213764" y="4116617"/>
            <a:ext cx="1330036" cy="18754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箭头连接符 82"/>
          <p:cNvCxnSpPr>
            <a:stCxn id="27" idx="1"/>
            <a:endCxn id="28" idx="3"/>
          </p:cNvCxnSpPr>
          <p:nvPr/>
        </p:nvCxnSpPr>
        <p:spPr>
          <a:xfrm>
            <a:off x="8810798" y="1453784"/>
            <a:ext cx="0" cy="5784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箭头连接符 84"/>
          <p:cNvCxnSpPr>
            <a:stCxn id="28" idx="1"/>
            <a:endCxn id="29" idx="3"/>
          </p:cNvCxnSpPr>
          <p:nvPr/>
        </p:nvCxnSpPr>
        <p:spPr>
          <a:xfrm>
            <a:off x="8810798" y="2919140"/>
            <a:ext cx="0" cy="5576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箭头连接符 86"/>
          <p:cNvCxnSpPr>
            <a:stCxn id="29" idx="1"/>
            <a:endCxn id="32" idx="3"/>
          </p:cNvCxnSpPr>
          <p:nvPr/>
        </p:nvCxnSpPr>
        <p:spPr>
          <a:xfrm>
            <a:off x="8810798" y="4078069"/>
            <a:ext cx="0" cy="4850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/>
          <p:cNvCxnSpPr>
            <a:stCxn id="28" idx="0"/>
          </p:cNvCxnSpPr>
          <p:nvPr/>
        </p:nvCxnSpPr>
        <p:spPr>
          <a:xfrm flipV="1">
            <a:off x="9938558" y="2463800"/>
            <a:ext cx="339975" cy="118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>
            <a:off x="10278533" y="2463800"/>
            <a:ext cx="0" cy="25828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箭头连接符 92"/>
          <p:cNvCxnSpPr>
            <a:endCxn id="32" idx="0"/>
          </p:cNvCxnSpPr>
          <p:nvPr/>
        </p:nvCxnSpPr>
        <p:spPr>
          <a:xfrm flipH="1" flipV="1">
            <a:off x="9938558" y="5046677"/>
            <a:ext cx="339975" cy="79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箭头连接符 98"/>
          <p:cNvCxnSpPr>
            <a:stCxn id="26" idx="3"/>
          </p:cNvCxnSpPr>
          <p:nvPr/>
        </p:nvCxnSpPr>
        <p:spPr>
          <a:xfrm>
            <a:off x="6213764" y="1641063"/>
            <a:ext cx="1469274" cy="31002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289516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1833819"/>
              </p:ext>
            </p:extLst>
          </p:nvPr>
        </p:nvGraphicFramePr>
        <p:xfrm>
          <a:off x="3810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3651965" y="1275009"/>
            <a:ext cx="5436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 </a:t>
            </a:r>
            <a:r>
              <a:rPr lang="en-US" altLang="zh-CN"/>
              <a:t>7</a:t>
            </a:r>
            <a:r>
              <a:rPr lang="en-US" altLang="zh-CN" smtClean="0"/>
              <a:t>, </a:t>
            </a:r>
            <a:r>
              <a:rPr lang="en-US" altLang="zh-CN" dirty="0" smtClean="0"/>
              <a:t>The Correlation Index of Hottest 20 Combinations 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3651965" y="1811179"/>
            <a:ext cx="10871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Correlation Index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>
            <a:off x="7614365" y="4180999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Sequence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60622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3228456"/>
              </p:ext>
            </p:extLst>
          </p:nvPr>
        </p:nvGraphicFramePr>
        <p:xfrm>
          <a:off x="3353946" y="151648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2086377" y="837127"/>
            <a:ext cx="7775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Fig </a:t>
            </a:r>
            <a:r>
              <a:rPr lang="en-US" altLang="zh-CN"/>
              <a:t>8</a:t>
            </a:r>
            <a:r>
              <a:rPr lang="en-US" altLang="zh-CN" smtClean="0"/>
              <a:t> </a:t>
            </a:r>
            <a:r>
              <a:rPr lang="en-US" altLang="zh-CN" smtClean="0"/>
              <a:t>The </a:t>
            </a:r>
            <a:r>
              <a:rPr lang="en-US" altLang="zh-CN" dirty="0" smtClean="0"/>
              <a:t>Relation between Correlation Index and the Number of Combinations 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2956560" y="1270267"/>
            <a:ext cx="14975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Number of Combinations</a:t>
            </a:r>
            <a:endParaRPr lang="zh-CN" altLang="en-US" sz="1000" dirty="0"/>
          </a:p>
        </p:txBody>
      </p:sp>
      <p:sp>
        <p:nvSpPr>
          <p:cNvPr id="9" name="文本框 8"/>
          <p:cNvSpPr txBox="1"/>
          <p:nvPr/>
        </p:nvSpPr>
        <p:spPr>
          <a:xfrm>
            <a:off x="6748460" y="4136577"/>
            <a:ext cx="10871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Correlation Index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2887449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/>
          </p:nvPr>
        </p:nvGraphicFramePr>
        <p:xfrm>
          <a:off x="3343275" y="1622425"/>
          <a:ext cx="5505450" cy="3613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文本框 6"/>
          <p:cNvSpPr txBox="1"/>
          <p:nvPr/>
        </p:nvSpPr>
        <p:spPr>
          <a:xfrm>
            <a:off x="3343275" y="1376204"/>
            <a:ext cx="14975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smtClean="0"/>
              <a:t>Number of References</a:t>
            </a:r>
            <a:endParaRPr lang="zh-CN" altLang="en-US" sz="1000" b="1"/>
          </a:p>
        </p:txBody>
      </p:sp>
      <p:sp>
        <p:nvSpPr>
          <p:cNvPr id="8" name="文本框 7"/>
          <p:cNvSpPr txBox="1"/>
          <p:nvPr/>
        </p:nvSpPr>
        <p:spPr>
          <a:xfrm>
            <a:off x="4478409" y="4989354"/>
            <a:ext cx="32351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30 Most Referenced Brain Regions at </a:t>
            </a:r>
            <a:r>
              <a:rPr lang="en-US" altLang="zh-CN" sz="1000" b="1" smtClean="0"/>
              <a:t>Multiple </a:t>
            </a:r>
            <a:r>
              <a:rPr lang="en-US" altLang="zh-CN" sz="1000" b="1"/>
              <a:t>S</a:t>
            </a:r>
            <a:r>
              <a:rPr lang="en-US" altLang="zh-CN" sz="1000" b="1" smtClean="0"/>
              <a:t>cales</a:t>
            </a:r>
            <a:endParaRPr lang="zh-CN" altLang="en-US" sz="1000" b="1"/>
          </a:p>
        </p:txBody>
      </p:sp>
      <p:cxnSp>
        <p:nvCxnSpPr>
          <p:cNvPr id="10" name="直接连接符 9"/>
          <p:cNvCxnSpPr/>
          <p:nvPr/>
        </p:nvCxnSpPr>
        <p:spPr>
          <a:xfrm>
            <a:off x="3819843" y="3568700"/>
            <a:ext cx="48733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V="1">
            <a:off x="3819843" y="1689100"/>
            <a:ext cx="0" cy="1879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67370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75</Words>
  <Application>Microsoft Office PowerPoint</Application>
  <PresentationFormat>宽屏</PresentationFormat>
  <Paragraphs>2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tp f</cp:lastModifiedBy>
  <cp:revision>7</cp:revision>
  <dcterms:created xsi:type="dcterms:W3CDTF">2019-03-14T07:47:09Z</dcterms:created>
  <dcterms:modified xsi:type="dcterms:W3CDTF">2020-08-02T14:51:56Z</dcterms:modified>
</cp:coreProperties>
</file>